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EDA8C-21DE-4CD5-B65C-3959E61F80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793CD-8E44-4845-B5C5-57A328479C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295D1-BBEE-4EFE-AF81-BF375AC217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1A041-7DF6-45AE-BE04-939F031DB0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8A481-1532-45A5-9EF7-724A3A4722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E7331-B8C5-40D3-B2F6-6BCCED3012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369079-D070-4AC0-A6AE-3C24D0D942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BBF9C-8623-470B-9F64-AF2E37975C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E100D-86AC-4856-A902-30333DFAF3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924D13-7D85-4F2C-87A9-D8C2F04C70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132BE-F527-4B43-B11B-D915BA9F67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D7FA4-2BF9-4CD7-B847-CCE140BBD4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4B51A2-F983-4DA9-B3DC-05C803A5271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343080" y="366840"/>
            <a:ext cx="617220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Additional Figure 1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7"/>
          <p:cNvGrpSpPr/>
          <p:nvPr/>
        </p:nvGrpSpPr>
        <p:grpSpPr>
          <a:xfrm>
            <a:off x="610920" y="1681200"/>
            <a:ext cx="3070080" cy="3873240"/>
            <a:chOff x="610920" y="1681200"/>
            <a:chExt cx="3070080" cy="3873240"/>
          </a:xfrm>
        </p:grpSpPr>
        <p:graphicFrame>
          <p:nvGraphicFramePr>
            <p:cNvPr id="43" name="Object 13"/>
            <p:cNvGraphicFramePr/>
            <p:nvPr/>
          </p:nvGraphicFramePr>
          <p:xfrm>
            <a:off x="914400" y="3506040"/>
            <a:ext cx="2666880" cy="20484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4" name="Object 13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914400" y="3506040"/>
                      <a:ext cx="2666880" cy="2048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45" name="Group 16"/>
            <p:cNvGrpSpPr/>
            <p:nvPr/>
          </p:nvGrpSpPr>
          <p:grpSpPr>
            <a:xfrm>
              <a:off x="610920" y="1681200"/>
              <a:ext cx="3070080" cy="1597680"/>
              <a:chOff x="610920" y="1681200"/>
              <a:chExt cx="3070080" cy="1597680"/>
            </a:xfrm>
          </p:grpSpPr>
          <p:pic>
            <p:nvPicPr>
              <p:cNvPr id="46" name="Picture 5" descr="well C1 488 and Hoechst"/>
              <p:cNvPicPr/>
              <p:nvPr/>
            </p:nvPicPr>
            <p:blipFill>
              <a:blip r:embed="rId3"/>
              <a:srcRect l="0" t="31302" r="74315" b="37396"/>
              <a:stretch/>
            </p:blipFill>
            <p:spPr>
              <a:xfrm>
                <a:off x="1295280" y="2046240"/>
                <a:ext cx="1067040" cy="991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 Box 6"/>
              <p:cNvSpPr/>
              <p:nvPr/>
            </p:nvSpPr>
            <p:spPr>
              <a:xfrm>
                <a:off x="1253520" y="2972160"/>
                <a:ext cx="1183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Endogenous DS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7"/>
              <p:cNvSpPr/>
              <p:nvPr/>
            </p:nvSpPr>
            <p:spPr>
              <a:xfrm>
                <a:off x="1220760" y="1724040"/>
                <a:ext cx="1278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eLa ORF2 Stab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 Box 10"/>
              <p:cNvSpPr/>
              <p:nvPr/>
            </p:nvSpPr>
            <p:spPr>
              <a:xfrm>
                <a:off x="2472840" y="3032640"/>
                <a:ext cx="11836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Endogenous DS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 Box 11"/>
              <p:cNvSpPr/>
              <p:nvPr/>
            </p:nvSpPr>
            <p:spPr>
              <a:xfrm>
                <a:off x="2451600" y="1681200"/>
                <a:ext cx="122940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eLa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ORF2 ER-- Stabl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1" name="Picture 12" descr="well B9 488 and Hoechst"/>
              <p:cNvPicPr/>
              <p:nvPr/>
            </p:nvPicPr>
            <p:blipFill>
              <a:blip r:embed="rId4"/>
              <a:srcRect l="70194" t="58060" r="0" b="9127"/>
              <a:stretch/>
            </p:blipFill>
            <p:spPr>
              <a:xfrm>
                <a:off x="2514600" y="2057400"/>
                <a:ext cx="1066680" cy="991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 Box 14"/>
              <p:cNvSpPr/>
              <p:nvPr/>
            </p:nvSpPr>
            <p:spPr>
              <a:xfrm>
                <a:off x="610920" y="1828800"/>
                <a:ext cx="46872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Arial"/>
                  </a:rPr>
                  <a:t>A.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" name="Text Box 15"/>
            <p:cNvSpPr/>
            <p:nvPr/>
          </p:nvSpPr>
          <p:spPr>
            <a:xfrm>
              <a:off x="610920" y="3277440"/>
              <a:ext cx="4687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Arial"/>
                </a:rPr>
                <a:t>B.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54" name="Picture 2" descr=""/>
          <p:cNvPicPr/>
          <p:nvPr/>
        </p:nvPicPr>
        <p:blipFill>
          <a:blip r:embed="rId5"/>
          <a:srcRect l="0" t="27273" r="0" b="51525"/>
          <a:stretch/>
        </p:blipFill>
        <p:spPr>
          <a:xfrm>
            <a:off x="1676520" y="6477120"/>
            <a:ext cx="2033640" cy="533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3" descr=""/>
          <p:cNvPicPr/>
          <p:nvPr/>
        </p:nvPicPr>
        <p:blipFill>
          <a:blip r:embed="rId6"/>
          <a:srcRect l="0" t="75762" r="0" b="0"/>
          <a:stretch/>
        </p:blipFill>
        <p:spPr>
          <a:xfrm>
            <a:off x="1676520" y="7010280"/>
            <a:ext cx="2033640" cy="609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6" name="TextBox 17"/>
          <p:cNvSpPr/>
          <p:nvPr/>
        </p:nvSpPr>
        <p:spPr>
          <a:xfrm>
            <a:off x="1600200" y="6095880"/>
            <a:ext cx="220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     1      2      3     4     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762120" y="662940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RF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8" name="Straight Arrow Connector 19"/>
          <p:cNvCxnSpPr/>
          <p:nvPr/>
        </p:nvCxnSpPr>
        <p:spPr>
          <a:xfrm>
            <a:off x="1371240" y="6781320"/>
            <a:ext cx="229320" cy="252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9" name="TextBox 20"/>
          <p:cNvSpPr/>
          <p:nvPr/>
        </p:nvSpPr>
        <p:spPr>
          <a:xfrm>
            <a:off x="762120" y="716292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Straight Arrow Connector 21"/>
          <p:cNvCxnSpPr/>
          <p:nvPr/>
        </p:nvCxnSpPr>
        <p:spPr>
          <a:xfrm>
            <a:off x="1371240" y="7315200"/>
            <a:ext cx="229320" cy="21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1" name="Text Box 15"/>
          <p:cNvSpPr/>
          <p:nvPr/>
        </p:nvSpPr>
        <p:spPr>
          <a:xfrm>
            <a:off x="612720" y="5791320"/>
            <a:ext cx="48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26T22:02:08Z</dcterms:created>
  <dc:creator>Student Computer</dc:creator>
  <dc:description/>
  <dc:language>en-US</dc:language>
  <cp:lastModifiedBy>Prescott Deininger</cp:lastModifiedBy>
  <dcterms:modified xsi:type="dcterms:W3CDTF">2010-07-21T15:53:12Z</dcterms:modified>
  <cp:revision>14</cp:revision>
  <dc:subject/>
  <dc:title>Slide 1</dc:title>
</cp:coreProperties>
</file>